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0BBC5D-6777-404F-999D-90CDF8DF36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6872E-C018-4328-8B6A-BF2FD81FC1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AA3C7-2B6C-4330-AA52-5E1ABAECA0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B3936-2968-4DFB-BD04-DAD76A2E0F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EB9402-8A9B-42DD-B818-9AFD72BAE2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257417-FD38-4FFA-BADE-AD36C412D1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036D4-DF36-438A-A632-E2B0551B3D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40300A-DD99-4344-AACF-6EF57AB412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E3113C-646C-4AAC-A502-69975E8FD3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62220-BEB0-416C-B750-B52C995317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883742-1053-4784-859D-45F7F3CA2D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A1695-27C3-4A35-A620-49FD323100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0D15DC-5275-4FD7-ACE7-376BE23E991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951480" y="5652360"/>
            <a:ext cx="7634520" cy="61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Fig. S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. Transimission electron microscope observation of CSO-SA/EMO nanomicell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(magnification =30000</a:t>
            </a:r>
            <a:r>
              <a:rPr b="1" lang="zh-CN" sz="1600" spc="-1" strike="noStrike">
                <a:solidFill>
                  <a:srgbClr val="000000"/>
                </a:solidFill>
                <a:latin typeface="Times New Roman"/>
              </a:rPr>
              <a:t>，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cale bar=1 </a:t>
            </a:r>
            <a:r>
              <a:rPr b="1" lang="el-GR" sz="16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图片 9" descr=""/>
          <p:cNvPicPr/>
          <p:nvPr/>
        </p:nvPicPr>
        <p:blipFill>
          <a:blip r:embed="rId1"/>
          <a:stretch/>
        </p:blipFill>
        <p:spPr>
          <a:xfrm>
            <a:off x="2473200" y="1447920"/>
            <a:ext cx="4197600" cy="3620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29T06:59:18Z</dcterms:created>
  <dc:creator>mingjuan li</dc:creator>
  <dc:description/>
  <dc:language>en-US</dc:language>
  <cp:lastModifiedBy> </cp:lastModifiedBy>
  <dcterms:modified xsi:type="dcterms:W3CDTF">2020-01-09T06:04:27Z</dcterms:modified>
  <cp:revision>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